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</p:sldIdLst>
  <p:sldSz cx="6858000" cy="9144000" type="letter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224" userDrawn="1">
          <p15:clr>
            <a:srgbClr val="A4A3A4"/>
          </p15:clr>
        </p15:guide>
        <p15:guide id="2" pos="696" userDrawn="1">
          <p15:clr>
            <a:srgbClr val="A4A3A4"/>
          </p15:clr>
        </p15:guide>
        <p15:guide id="3" orient="horz" pos="379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2B2B2"/>
    <a:srgbClr val="7E7E7E"/>
    <a:srgbClr val="D96766"/>
    <a:srgbClr val="E891F7"/>
    <a:srgbClr val="FFCCFF"/>
    <a:srgbClr val="FFFFCC"/>
    <a:srgbClr val="99FF99"/>
    <a:srgbClr val="FFFF99"/>
    <a:srgbClr val="B07BD7"/>
    <a:srgbClr val="934BC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119" autoAdjust="0"/>
    <p:restoredTop sz="94660"/>
  </p:normalViewPr>
  <p:slideViewPr>
    <p:cSldViewPr snapToGrid="0" showGuides="1">
      <p:cViewPr varScale="1">
        <p:scale>
          <a:sx n="81" d="100"/>
          <a:sy n="81" d="100"/>
        </p:scale>
        <p:origin x="2898" y="90"/>
      </p:cViewPr>
      <p:guideLst>
        <p:guide orient="horz" pos="1224"/>
        <p:guide pos="696"/>
        <p:guide orient="horz" pos="379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03C7C-FF66-472F-8A5E-D20B7F05A0E2}" type="datetimeFigureOut">
              <a:rPr lang="en-US" smtClean="0"/>
              <a:t>7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F6630-CC6C-4652-BC12-470D4F2DA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65430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03C7C-FF66-472F-8A5E-D20B7F05A0E2}" type="datetimeFigureOut">
              <a:rPr lang="en-US" smtClean="0"/>
              <a:t>7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F6630-CC6C-4652-BC12-470D4F2DA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32881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03C7C-FF66-472F-8A5E-D20B7F05A0E2}" type="datetimeFigureOut">
              <a:rPr lang="en-US" smtClean="0"/>
              <a:t>7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F6630-CC6C-4652-BC12-470D4F2DA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79616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03C7C-FF66-472F-8A5E-D20B7F05A0E2}" type="datetimeFigureOut">
              <a:rPr lang="en-US" smtClean="0"/>
              <a:t>7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F6630-CC6C-4652-BC12-470D4F2DA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55240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03C7C-FF66-472F-8A5E-D20B7F05A0E2}" type="datetimeFigureOut">
              <a:rPr lang="en-US" smtClean="0"/>
              <a:t>7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F6630-CC6C-4652-BC12-470D4F2DA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53053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03C7C-FF66-472F-8A5E-D20B7F05A0E2}" type="datetimeFigureOut">
              <a:rPr lang="en-US" smtClean="0"/>
              <a:t>7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F6630-CC6C-4652-BC12-470D4F2DA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58732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03C7C-FF66-472F-8A5E-D20B7F05A0E2}" type="datetimeFigureOut">
              <a:rPr lang="en-US" smtClean="0"/>
              <a:t>7/25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F6630-CC6C-4652-BC12-470D4F2DA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12782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03C7C-FF66-472F-8A5E-D20B7F05A0E2}" type="datetimeFigureOut">
              <a:rPr lang="en-US" smtClean="0"/>
              <a:t>7/25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F6630-CC6C-4652-BC12-470D4F2DA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34698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03C7C-FF66-472F-8A5E-D20B7F05A0E2}" type="datetimeFigureOut">
              <a:rPr lang="en-US" smtClean="0"/>
              <a:t>7/25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F6630-CC6C-4652-BC12-470D4F2DA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10585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03C7C-FF66-472F-8A5E-D20B7F05A0E2}" type="datetimeFigureOut">
              <a:rPr lang="en-US" smtClean="0"/>
              <a:t>7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F6630-CC6C-4652-BC12-470D4F2DA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90014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03C7C-FF66-472F-8A5E-D20B7F05A0E2}" type="datetimeFigureOut">
              <a:rPr lang="en-US" smtClean="0"/>
              <a:t>7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F6630-CC6C-4652-BC12-470D4F2DA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82817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E03C7C-FF66-472F-8A5E-D20B7F05A0E2}" type="datetimeFigureOut">
              <a:rPr lang="en-US" smtClean="0"/>
              <a:t>7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BF6630-CC6C-4652-BC12-470D4F2DA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2037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>
            <a:extLst>
              <a:ext uri="{FF2B5EF4-FFF2-40B4-BE49-F238E27FC236}">
                <a16:creationId xmlns:a16="http://schemas.microsoft.com/office/drawing/2014/main" id="{C49FDFBB-4898-435C-B889-474746DB26A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049" r="14314" b="8572"/>
          <a:stretch/>
        </p:blipFill>
        <p:spPr>
          <a:xfrm>
            <a:off x="689608" y="2029288"/>
            <a:ext cx="4567108" cy="3479866"/>
          </a:xfrm>
          <a:prstGeom prst="rect">
            <a:avLst/>
          </a:prstGeom>
        </p:spPr>
      </p:pic>
      <p:sp>
        <p:nvSpPr>
          <p:cNvPr id="130" name="TextBox 129">
            <a:extLst>
              <a:ext uri="{FF2B5EF4-FFF2-40B4-BE49-F238E27FC236}">
                <a16:creationId xmlns:a16="http://schemas.microsoft.com/office/drawing/2014/main" id="{9D8C1561-B7EB-48D0-918D-4D474B4C3DD4}"/>
              </a:ext>
            </a:extLst>
          </p:cNvPr>
          <p:cNvSpPr txBox="1"/>
          <p:nvPr/>
        </p:nvSpPr>
        <p:spPr>
          <a:xfrm>
            <a:off x="244931" y="210893"/>
            <a:ext cx="44087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126B985-0806-4AC0-B413-FF4BF7A01548}"/>
              </a:ext>
            </a:extLst>
          </p:cNvPr>
          <p:cNvSpPr txBox="1"/>
          <p:nvPr/>
        </p:nvSpPr>
        <p:spPr>
          <a:xfrm>
            <a:off x="358138" y="1814211"/>
            <a:ext cx="46944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ignificantly altered keratins</a:t>
            </a:r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19299C5F-C6E2-45A4-A4C8-E5665EA9C05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74832" y="6745137"/>
            <a:ext cx="1920406" cy="1524132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89DAD050-4B4D-4F92-85BC-BF42E56C459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9608" y="6125453"/>
            <a:ext cx="4139391" cy="2975481"/>
          </a:xfrm>
          <a:prstGeom prst="rect">
            <a:avLst/>
          </a:prstGeom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id="{C4FAF53D-A3FA-485C-B3F8-453FECB19FC5}"/>
              </a:ext>
            </a:extLst>
          </p:cNvPr>
          <p:cNvSpPr txBox="1"/>
          <p:nvPr/>
        </p:nvSpPr>
        <p:spPr>
          <a:xfrm>
            <a:off x="358139" y="5921989"/>
            <a:ext cx="46770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chematic illustration of keratins and desmosom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CC52978-B006-4C29-98E4-18404548F74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797" t="32403" r="15400" b="37643"/>
          <a:stretch/>
        </p:blipFill>
        <p:spPr>
          <a:xfrm>
            <a:off x="411484" y="892210"/>
            <a:ext cx="4833618" cy="471970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63706DCC-304F-4695-8464-66A84D1E1A1D}"/>
              </a:ext>
            </a:extLst>
          </p:cNvPr>
          <p:cNvSpPr txBox="1"/>
          <p:nvPr/>
        </p:nvSpPr>
        <p:spPr>
          <a:xfrm>
            <a:off x="358138" y="586751"/>
            <a:ext cx="44087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ignificantly altered serpin proteins</a:t>
            </a:r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id="{FFAD783E-B78E-418C-BEEC-63C375EE5840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5056" t="87896" r="14926" b="5845"/>
          <a:stretch/>
        </p:blipFill>
        <p:spPr>
          <a:xfrm>
            <a:off x="617221" y="1364179"/>
            <a:ext cx="4627880" cy="193141"/>
          </a:xfrm>
          <a:prstGeom prst="rect">
            <a:avLst/>
          </a:prstGeom>
        </p:spPr>
      </p:pic>
      <p:grpSp>
        <p:nvGrpSpPr>
          <p:cNvPr id="16" name="Group 15">
            <a:extLst>
              <a:ext uri="{FF2B5EF4-FFF2-40B4-BE49-F238E27FC236}">
                <a16:creationId xmlns:a16="http://schemas.microsoft.com/office/drawing/2014/main" id="{F9363266-9036-44A8-BF4C-8C456251D676}"/>
              </a:ext>
            </a:extLst>
          </p:cNvPr>
          <p:cNvGrpSpPr/>
          <p:nvPr/>
        </p:nvGrpSpPr>
        <p:grpSpPr>
          <a:xfrm>
            <a:off x="5163191" y="484027"/>
            <a:ext cx="1748790" cy="1829305"/>
            <a:chOff x="5299099" y="1278024"/>
            <a:chExt cx="1748790" cy="1829305"/>
          </a:xfrm>
        </p:grpSpPr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D2057571-B1CA-42F8-BA40-6F1203383C2E}"/>
                </a:ext>
              </a:extLst>
            </p:cNvPr>
            <p:cNvSpPr/>
            <p:nvPr/>
          </p:nvSpPr>
          <p:spPr>
            <a:xfrm>
              <a:off x="5299099" y="1278024"/>
              <a:ext cx="1748790" cy="66903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og</a:t>
              </a:r>
              <a:r>
                <a:rPr lang="en-US" sz="1200" baseline="-25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Tumor vs Matched Normal)</a:t>
              </a:r>
            </a:p>
          </p:txBody>
        </p:sp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CA6D7994-894E-48C8-BC32-998A229128E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86368" t="14637" r="3059" b="3915"/>
            <a:stretch/>
          </p:blipFill>
          <p:spPr>
            <a:xfrm>
              <a:off x="5983716" y="1823977"/>
              <a:ext cx="632459" cy="1283352"/>
            </a:xfrm>
            <a:prstGeom prst="rect">
              <a:avLst/>
            </a:prstGeom>
          </p:spPr>
        </p:pic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676095DB-7655-4FE8-8514-799C2176D15A}"/>
                </a:ext>
              </a:extLst>
            </p:cNvPr>
            <p:cNvCxnSpPr/>
            <p:nvPr/>
          </p:nvCxnSpPr>
          <p:spPr>
            <a:xfrm>
              <a:off x="6221890" y="1823977"/>
              <a:ext cx="52186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C11D6565-DFB4-4734-9198-163D9E5543C9}"/>
                </a:ext>
              </a:extLst>
            </p:cNvPr>
            <p:cNvCxnSpPr/>
            <p:nvPr/>
          </p:nvCxnSpPr>
          <p:spPr>
            <a:xfrm>
              <a:off x="6415808" y="1823916"/>
              <a:ext cx="52186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44" name="Picture 43">
            <a:extLst>
              <a:ext uri="{FF2B5EF4-FFF2-40B4-BE49-F238E27FC236}">
                <a16:creationId xmlns:a16="http://schemas.microsoft.com/office/drawing/2014/main" id="{B264E4D4-046D-4B95-BF0E-7652194BABC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5056" t="87896" r="14926" b="5845"/>
          <a:stretch/>
        </p:blipFill>
        <p:spPr>
          <a:xfrm>
            <a:off x="617221" y="5514349"/>
            <a:ext cx="4627880" cy="193141"/>
          </a:xfrm>
          <a:prstGeom prst="rect">
            <a:avLst/>
          </a:prstGeom>
        </p:spPr>
      </p:pic>
      <p:grpSp>
        <p:nvGrpSpPr>
          <p:cNvPr id="55" name="Group 54">
            <a:extLst>
              <a:ext uri="{FF2B5EF4-FFF2-40B4-BE49-F238E27FC236}">
                <a16:creationId xmlns:a16="http://schemas.microsoft.com/office/drawing/2014/main" id="{A5C0A8BC-D85F-4E3A-8268-6D482CD52AE2}"/>
              </a:ext>
            </a:extLst>
          </p:cNvPr>
          <p:cNvGrpSpPr/>
          <p:nvPr/>
        </p:nvGrpSpPr>
        <p:grpSpPr>
          <a:xfrm>
            <a:off x="5163191" y="2906693"/>
            <a:ext cx="1748790" cy="1704515"/>
            <a:chOff x="5163191" y="3160693"/>
            <a:chExt cx="1748790" cy="1704515"/>
          </a:xfrm>
        </p:grpSpPr>
        <p:grpSp>
          <p:nvGrpSpPr>
            <p:cNvPr id="45" name="Group 44">
              <a:extLst>
                <a:ext uri="{FF2B5EF4-FFF2-40B4-BE49-F238E27FC236}">
                  <a16:creationId xmlns:a16="http://schemas.microsoft.com/office/drawing/2014/main" id="{7534393D-D9A4-489D-94C4-8B748CEF87D6}"/>
                </a:ext>
              </a:extLst>
            </p:cNvPr>
            <p:cNvGrpSpPr/>
            <p:nvPr/>
          </p:nvGrpSpPr>
          <p:grpSpPr>
            <a:xfrm>
              <a:off x="5163191" y="3160693"/>
              <a:ext cx="1748790" cy="669032"/>
              <a:chOff x="5299099" y="1278024"/>
              <a:chExt cx="1748790" cy="669032"/>
            </a:xfrm>
          </p:grpSpPr>
          <p:sp>
            <p:nvSpPr>
              <p:cNvPr id="46" name="Rectangle 45">
                <a:extLst>
                  <a:ext uri="{FF2B5EF4-FFF2-40B4-BE49-F238E27FC236}">
                    <a16:creationId xmlns:a16="http://schemas.microsoft.com/office/drawing/2014/main" id="{723D60B6-63E5-4D37-AA5F-953BA7D4F4A7}"/>
                  </a:ext>
                </a:extLst>
              </p:cNvPr>
              <p:cNvSpPr/>
              <p:nvPr/>
            </p:nvSpPr>
            <p:spPr>
              <a:xfrm>
                <a:off x="5299099" y="1278024"/>
                <a:ext cx="1748790" cy="66903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og</a:t>
                </a:r>
                <a:r>
                  <a:rPr lang="en-US" sz="1200" baseline="-25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 </a:t>
                </a:r>
                <a:r>
                  <a: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Tumor vs Matched Normal)</a:t>
                </a:r>
              </a:p>
            </p:txBody>
          </p:sp>
          <p:cxnSp>
            <p:nvCxnSpPr>
              <p:cNvPr id="48" name="Straight Connector 47">
                <a:extLst>
                  <a:ext uri="{FF2B5EF4-FFF2-40B4-BE49-F238E27FC236}">
                    <a16:creationId xmlns:a16="http://schemas.microsoft.com/office/drawing/2014/main" id="{7FBC3D6E-F0DD-4AB5-AA34-F75F7BF9EB35}"/>
                  </a:ext>
                </a:extLst>
              </p:cNvPr>
              <p:cNvCxnSpPr/>
              <p:nvPr/>
            </p:nvCxnSpPr>
            <p:spPr>
              <a:xfrm>
                <a:off x="6221890" y="1823977"/>
                <a:ext cx="52186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Straight Connector 48">
                <a:extLst>
                  <a:ext uri="{FF2B5EF4-FFF2-40B4-BE49-F238E27FC236}">
                    <a16:creationId xmlns:a16="http://schemas.microsoft.com/office/drawing/2014/main" id="{390225D0-A67A-4320-9E17-53D679575E99}"/>
                  </a:ext>
                </a:extLst>
              </p:cNvPr>
              <p:cNvCxnSpPr/>
              <p:nvPr/>
            </p:nvCxnSpPr>
            <p:spPr>
              <a:xfrm>
                <a:off x="6415808" y="1823916"/>
                <a:ext cx="52186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50" name="Picture 49">
              <a:extLst>
                <a:ext uri="{FF2B5EF4-FFF2-40B4-BE49-F238E27FC236}">
                  <a16:creationId xmlns:a16="http://schemas.microsoft.com/office/drawing/2014/main" id="{2389F31C-758C-445B-8CD8-02C7B1B5309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87027" t="33855" r="2068" b="35701"/>
            <a:stretch/>
          </p:blipFill>
          <p:spPr>
            <a:xfrm>
              <a:off x="5847808" y="3706525"/>
              <a:ext cx="602707" cy="1158683"/>
            </a:xfrm>
            <a:prstGeom prst="rect">
              <a:avLst/>
            </a:prstGeom>
          </p:spPr>
        </p:pic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9997F789-95EC-4858-AF9B-7D1F02A21803}"/>
                </a:ext>
              </a:extLst>
            </p:cNvPr>
            <p:cNvCxnSpPr>
              <a:cxnSpLocks/>
            </p:cNvCxnSpPr>
            <p:nvPr/>
          </p:nvCxnSpPr>
          <p:spPr>
            <a:xfrm>
              <a:off x="6266841" y="3698789"/>
              <a:ext cx="20084" cy="10117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id="{B35B5FD4-13BC-4F38-B98B-F13D5E6A0E9B}"/>
                </a:ext>
              </a:extLst>
            </p:cNvPr>
            <p:cNvCxnSpPr>
              <a:cxnSpLocks/>
              <a:endCxn id="50" idx="0"/>
            </p:cNvCxnSpPr>
            <p:nvPr/>
          </p:nvCxnSpPr>
          <p:spPr>
            <a:xfrm flipV="1">
              <a:off x="6045288" y="3706525"/>
              <a:ext cx="103874" cy="16042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4563030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93</TotalTime>
  <Words>36</Words>
  <Application>Microsoft Office PowerPoint</Application>
  <PresentationFormat>Letter Paper (8.5x11 in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y O'Herlihy</dc:creator>
  <cp:lastModifiedBy>Joanna Bons</cp:lastModifiedBy>
  <cp:revision>53</cp:revision>
  <cp:lastPrinted>2022-07-12T21:38:47Z</cp:lastPrinted>
  <dcterms:created xsi:type="dcterms:W3CDTF">2022-07-08T21:00:20Z</dcterms:created>
  <dcterms:modified xsi:type="dcterms:W3CDTF">2022-07-25T16:32:30Z</dcterms:modified>
</cp:coreProperties>
</file>